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jpeg" ContentType="image/jpe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EAB7975-DE08-48E1-B1C8-9107B8DC154B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B3D904E-1B8D-4232-A739-C1A0794A9C9D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6492C62-9FF8-42E8-AF59-46A3E8F1B274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AE116E8-C80B-46CE-85F2-F8AA8B63A642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1359A4D-29DE-464B-872F-E4B426220E7C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1BB20D0-A003-47AC-B598-7488FB2283D7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FD380EB-00C2-49F1-BED6-709E80B00C1B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F01D699-D5DE-45EE-9E99-EDE49E3B3DE8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485FADD-A748-49C4-86FD-ADD628691B72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D08396E-72CF-4DA9-A9D2-4033D468E18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C55BE06-BB5A-405E-AF5D-C7BD3B73736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DFDEFAF-8802-484B-B4C0-7972EEC3C64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8ED9E99A-5BB4-410D-8656-59404D5AF7C8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PlaceHolder 1"/>
          <p:cNvSpPr>
            <a:spLocks noGrp="1"/>
          </p:cNvSpPr>
          <p:nvPr>
            <p:ph type="title"/>
          </p:nvPr>
        </p:nvSpPr>
        <p:spPr>
          <a:xfrm>
            <a:off x="1476000" y="5732640"/>
            <a:ext cx="6264360" cy="86328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 algn="just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</a:rPr>
              <a:t>Figure S1. The size distributions of three vector fragments. </a:t>
            </a:r>
            <a:r>
              <a:rPr b="1" lang="en-US" sz="1800" spc="-1" strike="noStrike">
                <a:solidFill>
                  <a:srgbClr val="000000"/>
                </a:solidFill>
                <a:latin typeface="Times New Roman"/>
              </a:rPr>
              <a:t>a,</a:t>
            </a:r>
            <a:r>
              <a:rPr b="0" lang="en-US" sz="1800" spc="-1" strike="noStrike">
                <a:solidFill>
                  <a:srgbClr val="000000"/>
                </a:solidFill>
                <a:latin typeface="Times New Roman"/>
              </a:rPr>
              <a:t> 161-base fragment; </a:t>
            </a:r>
            <a:r>
              <a:rPr b="1" lang="en-US" sz="1800" spc="-1" strike="noStrike">
                <a:solidFill>
                  <a:srgbClr val="000000"/>
                </a:solidFill>
                <a:latin typeface="Times New Roman"/>
              </a:rPr>
              <a:t>b,</a:t>
            </a:r>
            <a:r>
              <a:rPr b="0" lang="en-US" sz="1800" spc="-1" strike="noStrike">
                <a:solidFill>
                  <a:srgbClr val="000000"/>
                </a:solidFill>
                <a:latin typeface="Times New Roman"/>
              </a:rPr>
              <a:t> 230-base fragment; </a:t>
            </a:r>
            <a:r>
              <a:rPr b="1" lang="en-US" sz="1800" spc="-1" strike="noStrike">
                <a:solidFill>
                  <a:srgbClr val="000000"/>
                </a:solidFill>
                <a:latin typeface="Times New Roman"/>
              </a:rPr>
              <a:t>c,</a:t>
            </a:r>
            <a:r>
              <a:rPr b="0" lang="en-US" sz="1800" spc="-1" strike="noStrike">
                <a:solidFill>
                  <a:srgbClr val="000000"/>
                </a:solidFill>
                <a:latin typeface="Times New Roman"/>
              </a:rPr>
              <a:t> 375-base fragment.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2" name="Picture 18" descr="Vector fragment size distributions"/>
          <p:cNvPicPr/>
          <p:nvPr/>
        </p:nvPicPr>
        <p:blipFill>
          <a:blip r:embed="rId1"/>
          <a:stretch/>
        </p:blipFill>
        <p:spPr>
          <a:xfrm>
            <a:off x="2050920" y="260280"/>
            <a:ext cx="4610160" cy="534348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7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1-07-25T01:27:02Z</dcterms:created>
  <dc:creator>雨林木风</dc:creator>
  <dc:description/>
  <dc:language>en-US</dc:language>
  <cp:lastModifiedBy>Hong Bin</cp:lastModifiedBy>
  <dcterms:modified xsi:type="dcterms:W3CDTF">2011-08-18T19:58:47Z</dcterms:modified>
  <cp:revision>6</cp:revision>
  <dc:subject/>
  <dc:title>Vector fragment size distributions. a, 161-bp fragment; c, 230-bp fragment; c, 375-bp fragment.</dc:title>
</cp:coreProperties>
</file>